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6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07950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58511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34053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86672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2422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75857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34437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05060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497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86294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0493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B2D54-96F8-4F2D-A870-D3741BD64351}" type="datetimeFigureOut">
              <a:rPr lang="en-IN" smtClean="0"/>
              <a:t>11-08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B8B9E-031F-46E0-8204-ADC720F724F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2063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/>
          <p:cNvGrpSpPr/>
          <p:nvPr/>
        </p:nvGrpSpPr>
        <p:grpSpPr>
          <a:xfrm>
            <a:off x="644802" y="1003932"/>
            <a:ext cx="10626762" cy="4690696"/>
            <a:chOff x="190857" y="1501109"/>
            <a:chExt cx="16381484" cy="6683521"/>
          </a:xfrm>
        </p:grpSpPr>
        <p:sp>
          <p:nvSpPr>
            <p:cNvPr id="11" name="TextBox 10"/>
            <p:cNvSpPr txBox="1"/>
            <p:nvPr/>
          </p:nvSpPr>
          <p:spPr>
            <a:xfrm>
              <a:off x="201150" y="5414323"/>
              <a:ext cx="1944000" cy="99548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ourced mapping populations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190857" y="1691999"/>
              <a:ext cx="1944000" cy="44126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ental lines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17077" y="3844524"/>
              <a:ext cx="1944000" cy="99548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urce bi-parental mapping populations</a:t>
              </a:r>
              <a:endParaRPr lang="en-IN" sz="1013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201150" y="2714469"/>
              <a:ext cx="1944000" cy="718373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type of two </a:t>
              </a:r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E1</a:t>
              </a:r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oci</a:t>
              </a: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202333" y="7182532"/>
              <a:ext cx="1944000" cy="99548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gregation for erucic acid content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1572635" y="4010075"/>
              <a:ext cx="980079" cy="57575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 (296)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108286" y="4010075"/>
              <a:ext cx="956309" cy="57575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PJ (654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637892" y="4010075"/>
              <a:ext cx="1044702" cy="57575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H (1200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4511702" y="4010075"/>
              <a:ext cx="845573" cy="57575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D </a:t>
              </a:r>
              <a:r>
                <a:rPr lang="en-IN" sz="1013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IN" sz="101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3)</a:t>
              </a:r>
              <a:endParaRPr lang="en-IN" sz="101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591362" y="5569427"/>
              <a:ext cx="842185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</a:t>
              </a:r>
              <a:r>
                <a:rPr lang="en-IN" sz="1013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7</a:t>
              </a:r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63)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2374686" y="5569427"/>
              <a:ext cx="883088" cy="5757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</a:t>
              </a:r>
              <a:r>
                <a:rPr lang="en-IN" sz="1013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54)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083057" y="5569427"/>
              <a:ext cx="1053689" cy="585857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PJ</a:t>
              </a:r>
              <a:r>
                <a:rPr lang="en-IN" sz="1013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8B7</a:t>
              </a:r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82)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4464858" y="5569427"/>
              <a:ext cx="942970" cy="597392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D</a:t>
              </a:r>
              <a:r>
                <a:rPr lang="en-IN" sz="1013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8</a:t>
              </a:r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00)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804921" y="5569427"/>
              <a:ext cx="995923" cy="585857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H</a:t>
              </a:r>
              <a:r>
                <a:rPr lang="en-IN" sz="1013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8B7</a:t>
              </a:r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23)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9414063" y="5569427"/>
              <a:ext cx="816999" cy="5757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H</a:t>
              </a:r>
              <a:r>
                <a:rPr lang="en-IN" sz="1013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10)</a:t>
              </a:r>
            </a:p>
          </p:txBody>
        </p:sp>
        <p:cxnSp>
          <p:nvCxnSpPr>
            <p:cNvPr id="36" name="Straight Arrow Connector 35"/>
            <p:cNvCxnSpPr/>
            <p:nvPr/>
          </p:nvCxnSpPr>
          <p:spPr>
            <a:xfrm flipH="1">
              <a:off x="11224437" y="4774363"/>
              <a:ext cx="572935" cy="672304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 flipH="1">
              <a:off x="8245459" y="4774363"/>
              <a:ext cx="626651" cy="665664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/>
            <p:cNvCxnSpPr/>
            <p:nvPr/>
          </p:nvCxnSpPr>
          <p:spPr>
            <a:xfrm flipH="1">
              <a:off x="14918022" y="4774363"/>
              <a:ext cx="375" cy="684000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>
              <a:off x="12304874" y="4774363"/>
              <a:ext cx="603554" cy="654936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>
              <a:off x="9379612" y="4774363"/>
              <a:ext cx="565074" cy="642428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/>
            <p:nvPr/>
          </p:nvCxnSpPr>
          <p:spPr>
            <a:xfrm flipH="1">
              <a:off x="8198568" y="6631223"/>
              <a:ext cx="375" cy="472271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/>
            <p:cNvCxnSpPr/>
            <p:nvPr/>
          </p:nvCxnSpPr>
          <p:spPr>
            <a:xfrm flipH="1">
              <a:off x="9849678" y="6631223"/>
              <a:ext cx="375" cy="472271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/>
            <p:cNvCxnSpPr/>
            <p:nvPr/>
          </p:nvCxnSpPr>
          <p:spPr>
            <a:xfrm flipH="1">
              <a:off x="6529155" y="6631223"/>
              <a:ext cx="375" cy="472271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Arrow Connector 63"/>
            <p:cNvCxnSpPr/>
            <p:nvPr/>
          </p:nvCxnSpPr>
          <p:spPr>
            <a:xfrm flipH="1">
              <a:off x="11177842" y="6631223"/>
              <a:ext cx="375" cy="472271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Arrow Connector 64"/>
            <p:cNvCxnSpPr/>
            <p:nvPr/>
          </p:nvCxnSpPr>
          <p:spPr>
            <a:xfrm flipH="1">
              <a:off x="12761924" y="6631223"/>
              <a:ext cx="375" cy="472271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Arrow Connector 65"/>
            <p:cNvCxnSpPr/>
            <p:nvPr/>
          </p:nvCxnSpPr>
          <p:spPr>
            <a:xfrm flipH="1">
              <a:off x="14896566" y="6631223"/>
              <a:ext cx="373" cy="472270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/>
            <p:cNvSpPr txBox="1"/>
            <p:nvPr/>
          </p:nvSpPr>
          <p:spPr>
            <a:xfrm>
              <a:off x="10461955" y="1691856"/>
              <a:ext cx="1322649" cy="35366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nskaja-IV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2331389" y="1691565"/>
              <a:ext cx="796323" cy="35366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H-2</a:t>
              </a:r>
              <a:endParaRPr lang="en-IN" sz="1013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4913903" y="1692000"/>
              <a:ext cx="1335604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usa Jaikisan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3536727" y="1691565"/>
              <a:ext cx="880270" cy="366887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M-4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7844930" y="1691999"/>
              <a:ext cx="1035147" cy="44126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una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9342061" y="1691999"/>
              <a:ext cx="919591" cy="44126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era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6741240" y="1681306"/>
              <a:ext cx="837105" cy="44126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H-2</a:t>
              </a: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14997110" y="1691565"/>
              <a:ext cx="1453587" cy="35366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nskaja-IV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1797371" y="1730013"/>
              <a:ext cx="405733" cy="441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/>
                <a:t>X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6240238" y="1715792"/>
              <a:ext cx="402788" cy="441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/>
                <a:t>X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8840853" y="1692000"/>
              <a:ext cx="402788" cy="441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/>
                <a:t>X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4531701" y="1710007"/>
              <a:ext cx="402788" cy="441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/>
                <a:t>X</a:t>
              </a:r>
            </a:p>
          </p:txBody>
        </p:sp>
        <p:cxnSp>
          <p:nvCxnSpPr>
            <p:cNvPr id="133" name="Straight Arrow Connector 132"/>
            <p:cNvCxnSpPr/>
            <p:nvPr/>
          </p:nvCxnSpPr>
          <p:spPr>
            <a:xfrm flipH="1">
              <a:off x="6524686" y="3420189"/>
              <a:ext cx="375" cy="508599"/>
            </a:xfrm>
            <a:prstGeom prst="straightConnector1">
              <a:avLst/>
            </a:prstGeom>
            <a:ln w="444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Arrow Connector 133"/>
            <p:cNvCxnSpPr/>
            <p:nvPr/>
          </p:nvCxnSpPr>
          <p:spPr>
            <a:xfrm flipH="1">
              <a:off x="9034083" y="3420189"/>
              <a:ext cx="375" cy="508599"/>
            </a:xfrm>
            <a:prstGeom prst="straightConnector1">
              <a:avLst/>
            </a:prstGeom>
            <a:ln w="444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Arrow Connector 134"/>
            <p:cNvCxnSpPr/>
            <p:nvPr/>
          </p:nvCxnSpPr>
          <p:spPr>
            <a:xfrm flipH="1">
              <a:off x="12071952" y="3420189"/>
              <a:ext cx="375" cy="508599"/>
            </a:xfrm>
            <a:prstGeom prst="straightConnector1">
              <a:avLst/>
            </a:prstGeom>
            <a:ln w="444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Arrow Connector 135"/>
            <p:cNvCxnSpPr/>
            <p:nvPr/>
          </p:nvCxnSpPr>
          <p:spPr>
            <a:xfrm flipH="1">
              <a:off x="14792777" y="3420189"/>
              <a:ext cx="373" cy="508599"/>
            </a:xfrm>
            <a:prstGeom prst="straightConnector1">
              <a:avLst/>
            </a:prstGeom>
            <a:ln w="444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Arrow Connector 136"/>
            <p:cNvCxnSpPr/>
            <p:nvPr/>
          </p:nvCxnSpPr>
          <p:spPr>
            <a:xfrm>
              <a:off x="6532055" y="4774363"/>
              <a:ext cx="0" cy="670034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10735952" y="2722584"/>
              <a:ext cx="730661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12436486" y="2722584"/>
              <a:ext cx="714349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7928111" y="2722584"/>
              <a:ext cx="827667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9329755" y="2722584"/>
              <a:ext cx="696866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13724737" y="2722584"/>
              <a:ext cx="797664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15407827" y="2722584"/>
              <a:ext cx="728153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5112001" y="2722584"/>
              <a:ext cx="831506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6875751" y="2722584"/>
              <a:ext cx="695725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5982019" y="7344216"/>
              <a:ext cx="1141676" cy="44126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12278648" y="7344216"/>
              <a:ext cx="889200" cy="4412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7844930" y="7344216"/>
              <a:ext cx="889200" cy="44126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9354953" y="7344216"/>
              <a:ext cx="888269" cy="4412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10744015" y="7344216"/>
              <a:ext cx="889200" cy="44126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14416997" y="7344216"/>
              <a:ext cx="1141676" cy="44126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970868" y="4008961"/>
              <a:ext cx="1019564" cy="57575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J (1000)</a:t>
              </a:r>
              <a:endParaRPr lang="en-IN" sz="1013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448001" y="5569427"/>
              <a:ext cx="1033700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J8</a:t>
              </a:r>
              <a:r>
                <a:rPr lang="en-IN" sz="1013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8B7</a:t>
              </a:r>
            </a:p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66)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816000" y="5569427"/>
              <a:ext cx="836877" cy="5757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J8</a:t>
              </a:r>
              <a:r>
                <a:rPr lang="en-IN" sz="1013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</a:t>
              </a:r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66)</a:t>
              </a:r>
            </a:p>
          </p:txBody>
        </p:sp>
        <p:cxnSp>
          <p:nvCxnSpPr>
            <p:cNvPr id="35" name="Straight Arrow Connector 34"/>
            <p:cNvCxnSpPr/>
            <p:nvPr/>
          </p:nvCxnSpPr>
          <p:spPr>
            <a:xfrm flipH="1">
              <a:off x="2680436" y="4774363"/>
              <a:ext cx="585985" cy="729308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/>
            <p:cNvCxnSpPr/>
            <p:nvPr/>
          </p:nvCxnSpPr>
          <p:spPr>
            <a:xfrm>
              <a:off x="3784763" y="4774363"/>
              <a:ext cx="553729" cy="687884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/>
            <p:cNvCxnSpPr/>
            <p:nvPr/>
          </p:nvCxnSpPr>
          <p:spPr>
            <a:xfrm flipH="1">
              <a:off x="2970868" y="6631223"/>
              <a:ext cx="375" cy="472271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/>
            <p:cNvCxnSpPr/>
            <p:nvPr/>
          </p:nvCxnSpPr>
          <p:spPr>
            <a:xfrm flipH="1">
              <a:off x="4337944" y="6631223"/>
              <a:ext cx="375" cy="472271"/>
            </a:xfrm>
            <a:prstGeom prst="straightConnector1">
              <a:avLst/>
            </a:prstGeom>
            <a:ln w="539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/>
            <p:cNvSpPr txBox="1"/>
            <p:nvPr/>
          </p:nvSpPr>
          <p:spPr>
            <a:xfrm>
              <a:off x="2448000" y="1691999"/>
              <a:ext cx="595147" cy="44126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8</a:t>
              </a:r>
              <a:endParaRPr lang="en-IN" sz="1013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3816000" y="1691999"/>
              <a:ext cx="751531" cy="44126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H2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262670" y="1691999"/>
              <a:ext cx="402788" cy="441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/>
                <a:t>X</a:t>
              </a:r>
            </a:p>
          </p:txBody>
        </p:sp>
        <p:cxnSp>
          <p:nvCxnSpPr>
            <p:cNvPr id="128" name="Straight Arrow Connector 127"/>
            <p:cNvCxnSpPr/>
            <p:nvPr/>
          </p:nvCxnSpPr>
          <p:spPr>
            <a:xfrm flipH="1">
              <a:off x="3481701" y="3420189"/>
              <a:ext cx="375" cy="508599"/>
            </a:xfrm>
            <a:prstGeom prst="straightConnector1">
              <a:avLst/>
            </a:prstGeom>
            <a:ln w="444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2448001" y="2722981"/>
              <a:ext cx="814670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816000" y="2722978"/>
              <a:ext cx="722024" cy="575759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e1e2e2</a:t>
              </a:r>
              <a:endParaRPr lang="en-IN" sz="1013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2552191" y="7344216"/>
              <a:ext cx="815015" cy="44126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3915645" y="7344216"/>
              <a:ext cx="818174" cy="4412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1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2246573" y="1507396"/>
              <a:ext cx="2567687" cy="6670623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013"/>
            </a:p>
          </p:txBody>
        </p:sp>
        <p:sp>
          <p:nvSpPr>
            <p:cNvPr id="148" name="Rectangle 147"/>
            <p:cNvSpPr/>
            <p:nvPr/>
          </p:nvSpPr>
          <p:spPr>
            <a:xfrm>
              <a:off x="4871891" y="1514007"/>
              <a:ext cx="2830224" cy="6670623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013"/>
            </a:p>
          </p:txBody>
        </p:sp>
        <p:sp>
          <p:nvSpPr>
            <p:cNvPr id="149" name="Rectangle 148"/>
            <p:cNvSpPr/>
            <p:nvPr/>
          </p:nvSpPr>
          <p:spPr>
            <a:xfrm>
              <a:off x="7751920" y="1509896"/>
              <a:ext cx="2591541" cy="6670623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013"/>
            </a:p>
          </p:txBody>
        </p:sp>
        <p:sp>
          <p:nvSpPr>
            <p:cNvPr id="150" name="Rectangle 149"/>
            <p:cNvSpPr/>
            <p:nvPr/>
          </p:nvSpPr>
          <p:spPr>
            <a:xfrm>
              <a:off x="10392442" y="1507395"/>
              <a:ext cx="2989860" cy="6670623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013"/>
            </a:p>
          </p:txBody>
        </p:sp>
        <p:sp>
          <p:nvSpPr>
            <p:cNvPr id="151" name="Rectangle 150"/>
            <p:cNvSpPr/>
            <p:nvPr/>
          </p:nvSpPr>
          <p:spPr>
            <a:xfrm>
              <a:off x="13464112" y="1501109"/>
              <a:ext cx="3108229" cy="6670623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013"/>
            </a:p>
          </p:txBody>
        </p:sp>
      </p:grpSp>
      <p:sp>
        <p:nvSpPr>
          <p:cNvPr id="46" name="Rectangle 45"/>
          <p:cNvSpPr/>
          <p:nvPr/>
        </p:nvSpPr>
        <p:spPr>
          <a:xfrm>
            <a:off x="1845994" y="5940406"/>
            <a:ext cx="90990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IN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IN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I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IN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heme for sourcing of the eight </a:t>
            </a:r>
            <a:r>
              <a:rPr lang="en-I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-parental mapping populations used in the present study </a:t>
            </a:r>
          </a:p>
        </p:txBody>
      </p:sp>
    </p:spTree>
    <p:extLst>
      <p:ext uri="{BB962C8B-B14F-4D97-AF65-F5344CB8AC3E}">
        <p14:creationId xmlns:p14="http://schemas.microsoft.com/office/powerpoint/2010/main" val="2375712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24</Words>
  <Application>Microsoft Office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DAMBINI ROUT</dc:creator>
  <cp:lastModifiedBy>KADAMBINI ROUT</cp:lastModifiedBy>
  <cp:revision>13</cp:revision>
  <dcterms:created xsi:type="dcterms:W3CDTF">2018-07-30T06:03:26Z</dcterms:created>
  <dcterms:modified xsi:type="dcterms:W3CDTF">2018-08-11T06:58:10Z</dcterms:modified>
</cp:coreProperties>
</file>